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ng-ho Shin" initials="JS" lastIdx="4" clrIdx="0">
    <p:extLst>
      <p:ext uri="{19B8F6BF-5375-455C-9EA6-DF929625EA0E}">
        <p15:presenceInfo xmlns:p15="http://schemas.microsoft.com/office/powerpoint/2012/main" userId="Jung-ho Shin" providerId="None"/>
      </p:ext>
    </p:extLst>
  </p:cmAuthor>
  <p:cmAuthor id="2" name="Takuya Higuchi" initials="TH" lastIdx="4" clrIdx="1">
    <p:extLst>
      <p:ext uri="{19B8F6BF-5375-455C-9EA6-DF929625EA0E}">
        <p15:presenceInfo xmlns:p15="http://schemas.microsoft.com/office/powerpoint/2012/main" userId="Takuya Higuch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97" autoAdjust="0"/>
    <p:restoredTop sz="94660"/>
  </p:normalViewPr>
  <p:slideViewPr>
    <p:cSldViewPr snapToGrid="0" showGuides="1">
      <p:cViewPr varScale="1">
        <p:scale>
          <a:sx n="149" d="100"/>
          <a:sy n="149" d="100"/>
        </p:scale>
        <p:origin x="120" y="3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4D3B05-6379-407D-AA3F-58902711D3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C999DF4-D315-4F1B-8946-689C691CCA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EFF75B-E2F7-4C73-BBD1-D3BD1EEFE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44E345-AE15-48FD-B0E2-86288ACE3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2CDB58-9189-4450-B097-4F3351A69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597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D4F31D-8FCD-45FB-BA88-3C7E9AB4F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67FF7C3-6294-4B60-ADE3-BC67C5504D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6D7210-D86A-4A97-B3A7-6C9747088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FDDDA5D-1CC8-45E4-A7EE-6F862452D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FF8AD3-59F8-406D-98F1-97FE74AB4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6697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8B1223F-D891-4D53-8134-F95DAE5CAA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501FB78-40ED-46F0-9B04-3AE6F23CA7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73E728-EBEC-416A-A563-4DB80E651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841622-5006-43A0-A408-2FCDF5350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78BCFD-4D01-42DE-B206-D4A61C1F7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3556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9AAD52-99C3-46DB-A0A8-A7358E33B5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783166C-27CE-499E-B87B-1B571E83EA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D5649D9-5BB2-4026-9443-C30B5117F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A76BB5-F1FE-4FF1-B5A9-252394A70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7230F4-E755-4C28-9997-B7B659E2A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140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A11588-2584-4545-980A-A9F73C2010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1BD3FB4-8076-4AD7-880E-F5CCD9C942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D8C7D9-F4F9-43C6-9159-CAFC10946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A9FC22-B0C6-4E63-8300-A48DA484C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D407471-04F4-4190-8125-1A84CB0C16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0261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9FC5E0-59C1-4727-9D4D-AEA9F1B6C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006F27-0354-41A3-912B-6F31DA1028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010D253-5865-47D9-A359-87A7A76216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18D2F2C-9694-4F02-B1E8-43CBAF48E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CDEE763-9188-445D-A2E9-753B434C4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B8805A-AA78-4A3D-94E1-FD57E1F802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5487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4CE005-3A4A-49F0-B111-68D5BE7372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D88D32D-29B2-4433-B80A-636124808B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54A944F-A14A-4F9D-A260-D57D5052BE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869ECC2-895C-4ED1-AFCA-BCFFDB0C67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DE8599C-85A4-45F3-AEE8-51CE082114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CBA5DBB-BC31-4385-84BF-8AE4B94D8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177C0E8-BF54-4193-9485-6055960AC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5346776-3C1B-485E-9371-5191214A6D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751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8A1171-E070-4498-8DA6-C284DA4CCA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F6A1758-EAD3-434A-ABBF-26BB21C75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131659B-F1AA-4599-B0F8-8CD46ABCB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792A82D-4623-41D6-BE24-E2119939C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0019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675F44D-9AC8-4EF2-9BF5-4A80ABD38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AF6CFFF-EDE9-4FE7-BB07-F69EFE7A7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F576839-1878-4B81-BA44-899811665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7627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B6E536-3EDE-4889-8352-90307DF564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0D3472A-E1C9-461C-AF39-9618260FAB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418C87B-BEE1-4C71-90CF-D06CE4A99C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9E03E19-D5CA-40E7-9E59-F963EEF55A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B53CB2B-2753-45E5-B6BF-816FACCA5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1837BA-5DD9-4986-8301-B4F50491B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5023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21C689-5277-44C7-9027-DB1E3FD837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74DA17E-6A69-439E-AAE6-85A17E39CD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C30FA0C-394C-408F-87A4-F589711A0A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48260A-0CD8-411B-B65B-7AAE5966C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7B5665-267F-4A37-A1AA-538FA4A31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942194-94B9-44A2-B718-EBFECD6F4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1057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2D71CB9-6349-4A61-A26B-8CCA3E3AE4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5727A98-D29A-483B-A38F-1DEE61874E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887BD2-1535-48BC-A723-6199EE8267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74279A-56CE-46BB-B5CA-B6A46CBDDCC5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ED7C69-445C-40DA-9C58-E47DA87A89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D990DB-4CDA-4AED-A6F1-C7BE511DEA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CC4FD4-3733-4C69-9A49-2E72B15DD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732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0A104DCC-9079-4442-B682-6B9CC8E794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5975875"/>
              </p:ext>
            </p:extLst>
          </p:nvPr>
        </p:nvGraphicFramePr>
        <p:xfrm>
          <a:off x="2078143" y="337747"/>
          <a:ext cx="8767658" cy="603809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523659">
                  <a:extLst>
                    <a:ext uri="{9D8B030D-6E8A-4147-A177-3AD203B41FA5}">
                      <a16:colId xmlns:a16="http://schemas.microsoft.com/office/drawing/2014/main" val="3745444575"/>
                    </a:ext>
                  </a:extLst>
                </a:gridCol>
                <a:gridCol w="2415415">
                  <a:extLst>
                    <a:ext uri="{9D8B030D-6E8A-4147-A177-3AD203B41FA5}">
                      <a16:colId xmlns:a16="http://schemas.microsoft.com/office/drawing/2014/main" val="300018463"/>
                    </a:ext>
                  </a:extLst>
                </a:gridCol>
                <a:gridCol w="3828584">
                  <a:extLst>
                    <a:ext uri="{9D8B030D-6E8A-4147-A177-3AD203B41FA5}">
                      <a16:colId xmlns:a16="http://schemas.microsoft.com/office/drawing/2014/main" val="2757072035"/>
                    </a:ext>
                  </a:extLst>
                </a:gridCol>
              </a:tblGrid>
              <a:tr h="0">
                <a:tc gridSpan="3"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sz="1200" b="1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Supplementary Table 1. </a:t>
                      </a:r>
                      <a:r>
                        <a:rPr lang="en-US" sz="1200" b="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Variables, Types of Codes, and Corresponding Codes</a:t>
                      </a:r>
                      <a:endParaRPr lang="ja-JP" sz="1200" b="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64375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Variables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Types of Codes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odes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73463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OVID-19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ICD-10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B34.2, U07.1, U07.2.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9283622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Tracheostomy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laims </a:t>
                      </a:r>
                      <a:r>
                        <a:rPr kumimoji="1" lang="en-GB" altLang="ja-JP" sz="1200" b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ode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K386, K386-2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9346409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Endotracheal intubation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GB" altLang="ja-JP" sz="1200" b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laims Code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J044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6579843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Ventilation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GB" altLang="ja-JP" sz="1200" b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laims Code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J0451, J0453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060321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ECMO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GB" altLang="ja-JP" sz="1200" b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laims Code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K6021, K6022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5766025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Oxygen administration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GB" altLang="ja-JP" sz="1200" b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laims Code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J024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8351987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739200000, 739210000, 739220000, 739230000, 739240000, 739250000, 739260000, 739270000</a:t>
                      </a:r>
                      <a:endParaRPr lang="en-US" alt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7335071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High-flow therapy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GB" altLang="ja-JP" sz="1200" b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laims code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J026-41, J026-42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5653055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NPPV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GB" altLang="ja-JP" sz="1200" b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laims code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J026-2, J0454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1652284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Dexamethasone</a:t>
                      </a:r>
                      <a:endParaRPr lang="en-US" alt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NHI Drug Code (7 digits)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2454002, 2454405, 2454407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8914990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altLang="ja-JP" sz="1200" kern="100" dirty="0" err="1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Ciclesonide</a:t>
                      </a:r>
                      <a:endParaRPr lang="en-US" alt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u="none" strike="noStrike" kern="1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NHI Drug Code (7 digits)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2290702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4155408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Prednisolone</a:t>
                      </a:r>
                      <a:endParaRPr lang="en-US" alt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u="none" strike="noStrike" kern="1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NHI Drug Code (7 digits)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2456002, 2456001, 2456405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2494341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Methylprednisolone</a:t>
                      </a:r>
                      <a:endParaRPr lang="en-US" alt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NHI Drug Code (7 digits)</a:t>
                      </a:r>
                      <a:endParaRPr kumimoji="1" lang="ja-JP" altLang="ja-JP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indent="-513715" algn="l">
                        <a:lnSpc>
                          <a:spcPct val="200000"/>
                        </a:lnSpc>
                      </a:pP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2456003, 2456400, 2456402</a:t>
                      </a: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9608032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marL="0" marR="0" lvl="0" indent="-513715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Abbreviations: COVID-19, Coronavirus disease 2019; ICD-10, International Statistical Classification of Diseases and Related Health Problems, Tenth Revision; </a:t>
                      </a:r>
                      <a:r>
                        <a:rPr lang="en-GB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ECMO</a:t>
                      </a:r>
                      <a:r>
                        <a:rPr lang="en-US" altLang="ja-JP" sz="1200" kern="100" dirty="0">
                          <a:effectLst/>
                          <a:latin typeface="Segoe UI" panose="020B0502040204020203" pitchFamily="34" charset="0"/>
                          <a:cs typeface="Segoe UI" panose="020B0502040204020203" pitchFamily="34" charset="0"/>
                        </a:rPr>
                        <a:t>, Extracorporeal Membrane Oxygenation; NPPV, Non invasive Positive Pressure Ventilation; NHI, National Health Insurance;</a:t>
                      </a:r>
                      <a:endParaRPr lang="ja-JP" alt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marL="513715" indent="-513715" algn="l">
                        <a:lnSpc>
                          <a:spcPct val="200000"/>
                        </a:lnSpc>
                      </a:pP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 anchor="ctr"/>
                </a:tc>
                <a:tc hMerge="1">
                  <a:txBody>
                    <a:bodyPr/>
                    <a:lstStyle/>
                    <a:p>
                      <a:pPr marL="513715" indent="-513715" algn="l">
                        <a:lnSpc>
                          <a:spcPct val="200000"/>
                        </a:lnSpc>
                      </a:pPr>
                      <a:endParaRPr lang="ja-JP" sz="1200" kern="100" dirty="0">
                        <a:effectLst/>
                        <a:latin typeface="Segoe UI" panose="020B0502040204020203" pitchFamily="34" charset="0"/>
                        <a:ea typeface="游明朝" panose="02020400000000000000" pitchFamily="18" charset="-128"/>
                        <a:cs typeface="Segoe UI" panose="020B0502040204020203" pitchFamily="34" charset="0"/>
                      </a:endParaRPr>
                    </a:p>
                  </a:txBody>
                  <a:tcPr marL="62865" marR="62865" marT="0" marB="0"/>
                </a:tc>
                <a:extLst>
                  <a:ext uri="{0D108BD9-81ED-4DB2-BD59-A6C34878D82A}">
                    <a16:rowId xmlns:a16="http://schemas.microsoft.com/office/drawing/2014/main" val="39122589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63382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73</Words>
  <Application>Microsoft Office PowerPoint</Application>
  <PresentationFormat>ワイド画面</PresentationFormat>
  <Paragraphs>4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Segoe U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uya Higuchi</dc:creator>
  <cp:lastModifiedBy>Takuya Higuchi</cp:lastModifiedBy>
  <cp:revision>19</cp:revision>
  <dcterms:created xsi:type="dcterms:W3CDTF">2022-03-10T13:49:30Z</dcterms:created>
  <dcterms:modified xsi:type="dcterms:W3CDTF">2022-11-13T06:29:32Z</dcterms:modified>
</cp:coreProperties>
</file>